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2" r:id="rId2"/>
    <p:sldId id="263" r:id="rId3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77" d="100"/>
          <a:sy n="77" d="100"/>
        </p:scale>
        <p:origin x="356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625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205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252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902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0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254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463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465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425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515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553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CDAC0-E10E-2340-8C00-D4C524885263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932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B1C1602C-95E1-407F-91CB-7618960F5551}"/>
              </a:ext>
            </a:extLst>
          </p:cNvPr>
          <p:cNvGrpSpPr/>
          <p:nvPr/>
        </p:nvGrpSpPr>
        <p:grpSpPr>
          <a:xfrm>
            <a:off x="179948" y="0"/>
            <a:ext cx="7107777" cy="10058400"/>
            <a:chOff x="2148" y="0"/>
            <a:chExt cx="7107777" cy="100584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C12B14E-753A-1A4A-6723-B9F41AF87B6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48" y="0"/>
              <a:ext cx="7107777" cy="10058400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408AADD-A3A2-4A4E-85AC-D1AAB00BA1D7}"/>
                </a:ext>
              </a:extLst>
            </p:cNvPr>
            <p:cNvSpPr txBox="1"/>
            <p:nvPr/>
          </p:nvSpPr>
          <p:spPr>
            <a:xfrm>
              <a:off x="5917374" y="7422990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/>
                <a:t>**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68B4AA2-84F4-4B6F-AE08-16FB15263C38}"/>
                </a:ext>
              </a:extLst>
            </p:cNvPr>
            <p:cNvSpPr txBox="1"/>
            <p:nvPr/>
          </p:nvSpPr>
          <p:spPr>
            <a:xfrm>
              <a:off x="1606550" y="1276350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/>
                <a:t>****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4D9C275-4A22-42C9-B539-CB4E852BD8B1}"/>
                </a:ext>
              </a:extLst>
            </p:cNvPr>
            <p:cNvSpPr txBox="1"/>
            <p:nvPr/>
          </p:nvSpPr>
          <p:spPr>
            <a:xfrm>
              <a:off x="3751083" y="1339850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/>
                <a:t>****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2D2EF06-7832-43DE-B256-5A0DB36CDA62}"/>
                </a:ext>
              </a:extLst>
            </p:cNvPr>
            <p:cNvSpPr txBox="1"/>
            <p:nvPr/>
          </p:nvSpPr>
          <p:spPr>
            <a:xfrm>
              <a:off x="1702730" y="4946490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/>
                <a:t>*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D636115-F1F6-43CB-8AC7-CBF88F502366}"/>
                </a:ext>
              </a:extLst>
            </p:cNvPr>
            <p:cNvSpPr txBox="1"/>
            <p:nvPr/>
          </p:nvSpPr>
          <p:spPr>
            <a:xfrm>
              <a:off x="6173130" y="7422990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/>
                <a:t>*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1655564-1E57-4139-AF7B-F53C43E80E7A}"/>
                </a:ext>
              </a:extLst>
            </p:cNvPr>
            <p:cNvSpPr txBox="1"/>
            <p:nvPr/>
          </p:nvSpPr>
          <p:spPr>
            <a:xfrm>
              <a:off x="3736308" y="7655715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/>
                <a:t>****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DC066B6-65FB-4E94-A4C1-D66A9568A2B1}"/>
                </a:ext>
              </a:extLst>
            </p:cNvPr>
            <p:cNvSpPr txBox="1"/>
            <p:nvPr/>
          </p:nvSpPr>
          <p:spPr>
            <a:xfrm>
              <a:off x="1649855" y="7527050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/>
                <a:t>***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634921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1C3E38A-B8F8-30F3-859B-B7F94B17627F}"/>
              </a:ext>
            </a:extLst>
          </p:cNvPr>
          <p:cNvSpPr txBox="1"/>
          <p:nvPr/>
        </p:nvSpPr>
        <p:spPr>
          <a:xfrm>
            <a:off x="282633" y="399011"/>
            <a:ext cx="7032567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2. Delayed inhibition of IRAP following stroke increased CD11b cell counts within the cortical penumbra but did not attenuate neuronal cell death or alter GFAP positive cell counts. 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Immunohistochemistry was performed at 72 h post stroke with IRAP inhibition at 6, 24, 48 and 70 h post-stroke. </a:t>
            </a:r>
            <a:r>
              <a:rPr lang="en-AU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A-F)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No differences in </a:t>
            </a:r>
            <a:r>
              <a:rPr lang="en-AU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NeuN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or GRAP positive cell counts were detected with 1 nmol HFI419 treatment compared to vehicle treated controls. CD11b positive cell counts </a:t>
            </a:r>
            <a:r>
              <a:rPr lang="en-AU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G-I)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increased following stroke and were additionally increased within the </a:t>
            </a:r>
            <a:r>
              <a:rPr lang="en-AU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I)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cortical penumbra following HFI419 treatment</a:t>
            </a:r>
            <a:r>
              <a:rPr lang="en-AU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.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The data is represented as mean ± SEM and analysed using a two-way ANOVA followed by a Dunnett’s test where *P&lt;0.01 and **P&lt;0.01, ****P&lt;0.00001 (n=4-9).</a:t>
            </a:r>
            <a:endParaRPr lang="en-AU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2417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</TotalTime>
  <Words>150</Words>
  <Application>Microsoft Macintosh PowerPoint</Application>
  <PresentationFormat>Custom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on Telianidis</dc:creator>
  <cp:lastModifiedBy>Jonathon Telianidis</cp:lastModifiedBy>
  <cp:revision>8</cp:revision>
  <dcterms:created xsi:type="dcterms:W3CDTF">2022-09-14T04:52:36Z</dcterms:created>
  <dcterms:modified xsi:type="dcterms:W3CDTF">2023-07-23T23:35:53Z</dcterms:modified>
</cp:coreProperties>
</file>